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77" r:id="rId2"/>
  </p:sldIdLst>
  <p:sldSz cx="6858000" cy="9906000" type="A4"/>
  <p:notesSz cx="6797675" cy="987425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2020FE"/>
    <a:srgbClr val="FDB67A"/>
    <a:srgbClr val="FD9950"/>
    <a:srgbClr val="F797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40" autoAdjust="0"/>
    <p:restoredTop sz="94660"/>
  </p:normalViewPr>
  <p:slideViewPr>
    <p:cSldViewPr snapToGrid="0">
      <p:cViewPr varScale="1">
        <p:scale>
          <a:sx n="76" d="100"/>
          <a:sy n="76" d="100"/>
        </p:scale>
        <p:origin x="-1536" y="-8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42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E953184-A5AB-41E1-AADF-A482A5B901D6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6313" y="1233488"/>
            <a:ext cx="2305050" cy="3333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51983"/>
            <a:ext cx="5438140" cy="3887986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378824"/>
            <a:ext cx="2945659" cy="4954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7690749-9845-429A-94A2-81F5EE9EA55F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9695240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7268436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483271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462429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8479441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55570412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0880758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417941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9062917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017549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5394864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7800258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0A651A-723A-48BB-BE6B-3A99E62F6ECF}" type="datetimeFigureOut">
              <a:rPr lang="en-GB" smtClean="0"/>
              <a:t>21/11/2019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20FE-9CFF-4D07-9667-040A25A2ECC6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5315467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xmlns="" id="{CBAD260F-D43E-4448-8472-B13BFF54794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9996376"/>
              </p:ext>
            </p:extLst>
          </p:nvPr>
        </p:nvGraphicFramePr>
        <p:xfrm>
          <a:off x="422053" y="673740"/>
          <a:ext cx="3376845" cy="21082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18" name="Prism 8" r:id="rId3" imgW="4775039" imgH="2982075" progId="Prism8.Document">
                  <p:embed/>
                </p:oleObj>
              </mc:Choice>
              <mc:Fallback>
                <p:oleObj name="Prism 8" r:id="rId3" imgW="4775039" imgH="298207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22053" y="673740"/>
                        <a:ext cx="3376845" cy="21082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xmlns="" id="{B45E6C49-20C1-4104-A050-3078C056C23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7182474"/>
              </p:ext>
            </p:extLst>
          </p:nvPr>
        </p:nvGraphicFramePr>
        <p:xfrm>
          <a:off x="373716" y="2903062"/>
          <a:ext cx="3473517" cy="213597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19" name="Prism 8" r:id="rId5" imgW="4848147" imgH="2982075" progId="Prism8.Document">
                  <p:embed/>
                </p:oleObj>
              </mc:Choice>
              <mc:Fallback>
                <p:oleObj name="Prism 8" r:id="rId5" imgW="4848147" imgH="298207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73716" y="2903062"/>
                        <a:ext cx="3473517" cy="213597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xmlns="" id="{1EEE499D-2D87-471E-B6E0-C4F87D5B7F8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0153269"/>
              </p:ext>
            </p:extLst>
          </p:nvPr>
        </p:nvGraphicFramePr>
        <p:xfrm>
          <a:off x="373716" y="5160075"/>
          <a:ext cx="3473518" cy="2135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620" name="Prism 8" r:id="rId7" imgW="4848147" imgH="2982075" progId="Prism8.Document">
                  <p:embed/>
                </p:oleObj>
              </mc:Choice>
              <mc:Fallback>
                <p:oleObj name="Prism 8" r:id="rId7" imgW="4848147" imgH="298207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73716" y="5160075"/>
                        <a:ext cx="3473518" cy="2135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630DC9FC-0D41-4DE9-BF2D-FBE2D997320C}"/>
              </a:ext>
            </a:extLst>
          </p:cNvPr>
          <p:cNvSpPr txBox="1"/>
          <p:nvPr/>
        </p:nvSpPr>
        <p:spPr>
          <a:xfrm>
            <a:off x="142809" y="653396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xmlns="" id="{79691B0C-14DF-4A1B-B66E-C01F27C6B11E}"/>
              </a:ext>
            </a:extLst>
          </p:cNvPr>
          <p:cNvSpPr txBox="1"/>
          <p:nvPr/>
        </p:nvSpPr>
        <p:spPr>
          <a:xfrm>
            <a:off x="142809" y="2903062"/>
            <a:ext cx="2856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xmlns="" id="{1710591C-1E76-4EC1-8140-8B485357A410}"/>
              </a:ext>
            </a:extLst>
          </p:cNvPr>
          <p:cNvSpPr txBox="1"/>
          <p:nvPr/>
        </p:nvSpPr>
        <p:spPr>
          <a:xfrm>
            <a:off x="142809" y="5152728"/>
            <a:ext cx="2792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/>
              <a:t>C</a:t>
            </a:r>
          </a:p>
        </p:txBody>
      </p:sp>
      <p:sp>
        <p:nvSpPr>
          <p:cNvPr id="11" name="Rectangle 10">
            <a:extLst>
              <a:ext uri="{FF2B5EF4-FFF2-40B4-BE49-F238E27FC236}">
                <a16:creationId xmlns:a16="http://schemas.microsoft.com/office/drawing/2014/main" xmlns="" id="{4E885C68-D3E7-4A9B-99DB-1E4CAAAD8962}"/>
              </a:ext>
            </a:extLst>
          </p:cNvPr>
          <p:cNvSpPr/>
          <p:nvPr/>
        </p:nvSpPr>
        <p:spPr>
          <a:xfrm>
            <a:off x="142808" y="7839230"/>
            <a:ext cx="6534717" cy="97667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Supplementary Figure 2 – Expression of PD-L1 on CD11b+ and CD45- cells.</a:t>
            </a:r>
          </a:p>
          <a:p>
            <a:pPr lvl="0">
              <a:lnSpc>
                <a:spcPct val="107000"/>
              </a:lnSpc>
              <a:spcAft>
                <a:spcPts val="800"/>
              </a:spcAft>
            </a:pPr>
            <a:r>
              <a:rPr lang="en-US" sz="1200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Expression (MFI) of PD-L1 in </a:t>
            </a: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A)</a:t>
            </a:r>
            <a:r>
              <a:rPr lang="en-US" sz="1200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CT26 </a:t>
            </a: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B)</a:t>
            </a:r>
            <a:r>
              <a:rPr lang="en-US" sz="1200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MC38 and </a:t>
            </a:r>
            <a:r>
              <a:rPr lang="en-US" sz="1200" b="1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(C)</a:t>
            </a:r>
            <a:r>
              <a:rPr lang="en-US" sz="1200" dirty="0">
                <a:solidFill>
                  <a:prstClr val="black"/>
                </a:solidFill>
                <a:ea typeface="Calibri" panose="020F0502020204030204" pitchFamily="34" charset="0"/>
                <a:cs typeface="Times New Roman" panose="02020603050405020304" pitchFamily="18" charset="0"/>
              </a:rPr>
              <a:t> 4T1. </a:t>
            </a:r>
            <a:r>
              <a:rPr lang="en-GB" sz="1200" dirty="0"/>
              <a:t>Statistical significance is indicated as NS=not significant,  *p&lt;0.05, **p&lt;0.01,***p&lt;0.001, ****p&lt;0.0001 and compares the final timepoint to the mid-timepoint.</a:t>
            </a:r>
            <a:endParaRPr lang="en-GB" sz="1200" dirty="0">
              <a:solidFill>
                <a:prstClr val="black"/>
              </a:solidFill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A53D8930-989C-4A60-B5DF-164FB4FF4305}"/>
              </a:ext>
            </a:extLst>
          </p:cNvPr>
          <p:cNvSpPr txBox="1"/>
          <p:nvPr/>
        </p:nvSpPr>
        <p:spPr>
          <a:xfrm>
            <a:off x="84220" y="216568"/>
            <a:ext cx="287554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9593048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421</TotalTime>
  <Words>68</Words>
  <Application>Microsoft Office PowerPoint</Application>
  <PresentationFormat>A4 Paper (210x297 mm)</PresentationFormat>
  <Paragraphs>6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8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aylor, Molly</dc:creator>
  <cp:lastModifiedBy>Azarse, Elma Kadile</cp:lastModifiedBy>
  <cp:revision>302</cp:revision>
  <cp:lastPrinted>2019-02-05T09:56:44Z</cp:lastPrinted>
  <dcterms:created xsi:type="dcterms:W3CDTF">2018-07-09T15:32:49Z</dcterms:created>
  <dcterms:modified xsi:type="dcterms:W3CDTF">2019-11-21T12:49:39Z</dcterms:modified>
</cp:coreProperties>
</file>